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946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rchidea233 orchidea233" userId="70f7380ddf000356" providerId="LiveId" clId="{6E1D7936-1D23-44BC-83C6-16EC1BE20344}"/>
    <pc:docChg chg="undo custSel modSld">
      <pc:chgData name="orchidea233 orchidea233" userId="70f7380ddf000356" providerId="LiveId" clId="{6E1D7936-1D23-44BC-83C6-16EC1BE20344}" dt="2022-10-24T19:22:28.748" v="53" actId="20577"/>
      <pc:docMkLst>
        <pc:docMk/>
      </pc:docMkLst>
      <pc:sldChg chg="modSp mod">
        <pc:chgData name="orchidea233 orchidea233" userId="70f7380ddf000356" providerId="LiveId" clId="{6E1D7936-1D23-44BC-83C6-16EC1BE20344}" dt="2022-10-24T19:00:49.094" v="20" actId="20577"/>
        <pc:sldMkLst>
          <pc:docMk/>
          <pc:sldMk cId="3248453473" sldId="256"/>
        </pc:sldMkLst>
        <pc:spChg chg="mod">
          <ac:chgData name="orchidea233 orchidea233" userId="70f7380ddf000356" providerId="LiveId" clId="{6E1D7936-1D23-44BC-83C6-16EC1BE20344}" dt="2022-10-24T19:00:49.094" v="20" actId="20577"/>
          <ac:spMkLst>
            <pc:docMk/>
            <pc:sldMk cId="3248453473" sldId="256"/>
            <ac:spMk id="5" creationId="{00000000-0000-0000-0000-000000000000}"/>
          </ac:spMkLst>
        </pc:spChg>
      </pc:sldChg>
      <pc:sldChg chg="modSp mod">
        <pc:chgData name="orchidea233 orchidea233" userId="70f7380ddf000356" providerId="LiveId" clId="{6E1D7936-1D23-44BC-83C6-16EC1BE20344}" dt="2022-10-24T19:01:50.236" v="44" actId="20577"/>
        <pc:sldMkLst>
          <pc:docMk/>
          <pc:sldMk cId="3623329939" sldId="258"/>
        </pc:sldMkLst>
        <pc:spChg chg="mod">
          <ac:chgData name="orchidea233 orchidea233" userId="70f7380ddf000356" providerId="LiveId" clId="{6E1D7936-1D23-44BC-83C6-16EC1BE20344}" dt="2022-10-24T19:01:50.236" v="44" actId="20577"/>
          <ac:spMkLst>
            <pc:docMk/>
            <pc:sldMk cId="3623329939" sldId="258"/>
            <ac:spMk id="13" creationId="{00000000-0000-0000-0000-000000000000}"/>
          </ac:spMkLst>
        </pc:spChg>
      </pc:sldChg>
      <pc:sldChg chg="modSp mod">
        <pc:chgData name="orchidea233 orchidea233" userId="70f7380ddf000356" providerId="LiveId" clId="{6E1D7936-1D23-44BC-83C6-16EC1BE20344}" dt="2022-10-24T19:22:28.748" v="53" actId="20577"/>
        <pc:sldMkLst>
          <pc:docMk/>
          <pc:sldMk cId="2625085329" sldId="259"/>
        </pc:sldMkLst>
        <pc:spChg chg="mod">
          <ac:chgData name="orchidea233 orchidea233" userId="70f7380ddf000356" providerId="LiveId" clId="{6E1D7936-1D23-44BC-83C6-16EC1BE20344}" dt="2022-10-24T19:22:28.748" v="53" actId="20577"/>
          <ac:spMkLst>
            <pc:docMk/>
            <pc:sldMk cId="2625085329" sldId="259"/>
            <ac:spMk id="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668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553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644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450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29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381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711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193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945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83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608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ED335-E96A-408D-A3BF-390682CD3719}" type="datetimeFigureOut">
              <a:rPr lang="en-US" smtClean="0"/>
              <a:t>11/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9C5757-7567-4A56-820D-A3C2AFC3C5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917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14600"/>
            <a:ext cx="8229600" cy="1143000"/>
          </a:xfrm>
        </p:spPr>
        <p:txBody>
          <a:bodyPr>
            <a:normAutofit fontScale="90000"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222222"/>
                </a:solidFill>
                <a:effectLst/>
                <a:latin typeface="Times New Roman"/>
                <a:ea typeface="Times New Roman"/>
                <a:cs typeface="Times New Roman"/>
              </a:rPr>
              <a:t>Linoleic acid binds to SARS-CoV-2 </a:t>
            </a:r>
            <a:r>
              <a:rPr lang="en-US" sz="1800" b="1" dirty="0" err="1">
                <a:solidFill>
                  <a:srgbClr val="222222"/>
                </a:solidFill>
                <a:effectLst/>
                <a:latin typeface="Times New Roman"/>
                <a:ea typeface="Times New Roman"/>
                <a:cs typeface="Times New Roman"/>
              </a:rPr>
              <a:t>RdRp</a:t>
            </a:r>
            <a:r>
              <a:rPr lang="en-US" sz="1800" b="1" dirty="0">
                <a:solidFill>
                  <a:srgbClr val="222222"/>
                </a:solidFill>
                <a:effectLst/>
                <a:latin typeface="Times New Roman"/>
                <a:ea typeface="Times New Roman"/>
                <a:cs typeface="Times New Roman"/>
              </a:rPr>
              <a:t> and represses replication of seasonal human coronavirus OC43</a:t>
            </a:r>
            <a:r>
              <a:rPr lang="en-US" sz="1800" dirty="0">
                <a:ea typeface="Calibri"/>
                <a:cs typeface="Times New Roman"/>
              </a:rPr>
              <a:t/>
            </a:r>
            <a:br>
              <a:rPr lang="en-US" sz="1800" dirty="0">
                <a:ea typeface="Calibri"/>
                <a:cs typeface="Times New Roman"/>
              </a:rPr>
            </a:br>
            <a:r>
              <a:rPr lang="en-US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 </a:t>
            </a:r>
            <a:r>
              <a:rPr lang="en-US" sz="2000" dirty="0">
                <a:effectLst/>
                <a:latin typeface="Times New Roman"/>
                <a:ea typeface="Times New Roman"/>
              </a:rPr>
              <a:t/>
            </a:r>
            <a:br>
              <a:rPr lang="en-US" sz="2000" dirty="0">
                <a:effectLst/>
                <a:latin typeface="Times New Roman"/>
                <a:ea typeface="Times New Roman"/>
              </a:rPr>
            </a:br>
            <a:r>
              <a:rPr lang="pl-PL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Anna Goc</a:t>
            </a:r>
            <a:r>
              <a:rPr lang="pl-PL" sz="2000" baseline="30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1*</a:t>
            </a:r>
            <a:r>
              <a:rPr lang="pl-PL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, </a:t>
            </a:r>
            <a:r>
              <a:rPr lang="en-US" sz="2000" dirty="0" err="1" smtClean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Waldemar</a:t>
            </a:r>
            <a:r>
              <a:rPr lang="en-US" sz="2000" dirty="0" smtClean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 Sumera</a:t>
            </a:r>
            <a:r>
              <a:rPr lang="en-US" sz="2000" baseline="30000" dirty="0" smtClean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1</a:t>
            </a:r>
            <a:r>
              <a:rPr lang="en-US" sz="2000" dirty="0" smtClean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, </a:t>
            </a:r>
            <a:r>
              <a:rPr lang="pl-PL" sz="2000" dirty="0" smtClean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Matthias </a:t>
            </a:r>
            <a:r>
              <a:rPr lang="pl-PL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Rath</a:t>
            </a:r>
            <a:r>
              <a:rPr lang="pl-PL" sz="2000" baseline="30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1</a:t>
            </a: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srgbClr val="222222"/>
                </a:solidFill>
                <a:effectLst/>
                <a:uLnTx/>
                <a:uFillTx/>
                <a:latin typeface="Times New Roman"/>
                <a:ea typeface="Times New Roman"/>
                <a:cs typeface="+mj-cs"/>
              </a:rPr>
              <a:t>, </a:t>
            </a:r>
            <a:r>
              <a:rPr kumimoji="0" lang="pl-PL" sz="2000" b="0" i="0" u="none" strike="noStrike" kern="1200" cap="none" spc="0" normalizeH="0" baseline="0" noProof="0" dirty="0">
                <a:ln>
                  <a:noFill/>
                </a:ln>
                <a:solidFill>
                  <a:srgbClr val="222222"/>
                </a:solidFill>
                <a:effectLst/>
                <a:uLnTx/>
                <a:uFillTx/>
                <a:latin typeface="Times New Roman"/>
                <a:ea typeface="Times New Roman"/>
                <a:cs typeface="+mj-cs"/>
              </a:rPr>
              <a:t>Aleksandra Niedzwiecki</a:t>
            </a:r>
            <a:r>
              <a:rPr kumimoji="0" lang="pl-PL" sz="2000" b="0" i="0" u="none" strike="noStrike" kern="1200" cap="none" spc="0" normalizeH="0" baseline="30000" noProof="0" dirty="0">
                <a:ln>
                  <a:noFill/>
                </a:ln>
                <a:solidFill>
                  <a:srgbClr val="222222"/>
                </a:solidFill>
                <a:effectLst/>
                <a:uLnTx/>
                <a:uFillTx/>
                <a:latin typeface="Times New Roman"/>
                <a:ea typeface="Times New Roman"/>
                <a:cs typeface="+mj-cs"/>
              </a:rPr>
              <a:t>1*</a:t>
            </a:r>
            <a:r>
              <a:rPr lang="en-US" sz="2000" dirty="0">
                <a:effectLst/>
                <a:latin typeface="Times New Roman"/>
                <a:ea typeface="Times New Roman"/>
              </a:rPr>
              <a:t/>
            </a:r>
            <a:br>
              <a:rPr lang="en-US" sz="2000" dirty="0">
                <a:effectLst/>
                <a:latin typeface="Times New Roman"/>
                <a:ea typeface="Times New Roman"/>
              </a:rPr>
            </a:br>
            <a:r>
              <a:rPr lang="en-US" sz="2000" baseline="30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1</a:t>
            </a:r>
            <a:r>
              <a:rPr lang="en-US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Dr. </a:t>
            </a:r>
            <a:r>
              <a:rPr lang="en-US" sz="2000" dirty="0" err="1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Rath</a:t>
            </a:r>
            <a:r>
              <a:rPr lang="en-US" sz="2000" dirty="0">
                <a:solidFill>
                  <a:srgbClr val="222222"/>
                </a:solidFill>
                <a:effectLst/>
                <a:latin typeface="Times New Roman"/>
                <a:ea typeface="Times New Roman"/>
              </a:rPr>
              <a:t> Research Institute, 5941 Optical Ct., San Jose, CA 95138, USA</a:t>
            </a:r>
            <a:r>
              <a:rPr lang="en-US" sz="2000" dirty="0">
                <a:effectLst/>
                <a:latin typeface="Times New Roman"/>
                <a:ea typeface="Times New Roman"/>
              </a:rPr>
              <a:t/>
            </a:r>
            <a:br>
              <a:rPr lang="en-US" sz="2000" dirty="0">
                <a:effectLst/>
                <a:latin typeface="Times New Roman"/>
                <a:ea typeface="Times New Roman"/>
              </a:rPr>
            </a:br>
            <a:endParaRPr lang="en-US" sz="2000" dirty="0"/>
          </a:p>
        </p:txBody>
      </p:sp>
      <p:sp>
        <p:nvSpPr>
          <p:cNvPr id="3" name="TextBox 2"/>
          <p:cNvSpPr txBox="1"/>
          <p:nvPr/>
        </p:nvSpPr>
        <p:spPr>
          <a:xfrm>
            <a:off x="838200" y="762000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Information</a:t>
            </a:r>
          </a:p>
        </p:txBody>
      </p:sp>
    </p:spTree>
    <p:extLst>
      <p:ext uri="{BB962C8B-B14F-4D97-AF65-F5344CB8AC3E}">
        <p14:creationId xmlns:p14="http://schemas.microsoft.com/office/powerpoint/2010/main" val="26250853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608069" y="4885138"/>
            <a:ext cx="487986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ACE2 expression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protein leve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A549 cells treated with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LA for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do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Western blot metho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ACE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lonal antibody 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500 dilution on PVDF membra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e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β-actin antibody at 1:1000 dilution as a loa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g/well of protein was separated on 8-16% gradient SDS-PAGE gels. Original WB images were acquired using the Azu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eri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gital system and auto-exposure settings.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52400" y="173317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S1</a:t>
            </a:r>
            <a:endParaRPr 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6000125" y="533317"/>
            <a:ext cx="1813894" cy="226953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925703" y="2451745"/>
            <a:ext cx="1964522" cy="226774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955865" y="4434175"/>
            <a:ext cx="1902414" cy="2269529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9387" y="1186398"/>
            <a:ext cx="4197226" cy="34671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879413" y="2370797"/>
            <a:ext cx="609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ACE2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722614" y="2936544"/>
            <a:ext cx="766399" cy="316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sp>
        <p:nvSpPr>
          <p:cNvPr id="23" name="TextBox 22"/>
          <p:cNvSpPr txBox="1"/>
          <p:nvPr/>
        </p:nvSpPr>
        <p:spPr>
          <a:xfrm rot="18724095">
            <a:off x="1441336" y="1217436"/>
            <a:ext cx="7424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/>
              <a:t>Control</a:t>
            </a:r>
          </a:p>
        </p:txBody>
      </p:sp>
      <p:sp>
        <p:nvSpPr>
          <p:cNvPr id="24" name="TextBox 23"/>
          <p:cNvSpPr txBox="1"/>
          <p:nvPr/>
        </p:nvSpPr>
        <p:spPr>
          <a:xfrm rot="18724095">
            <a:off x="1431908" y="1099359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25 µg/ml</a:t>
            </a:r>
            <a:endParaRPr lang="en-US" sz="1300" dirty="0"/>
          </a:p>
        </p:txBody>
      </p:sp>
      <p:sp>
        <p:nvSpPr>
          <p:cNvPr id="25" name="TextBox 24"/>
          <p:cNvSpPr txBox="1"/>
          <p:nvPr/>
        </p:nvSpPr>
        <p:spPr>
          <a:xfrm rot="18724095">
            <a:off x="1773272" y="1104541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50 µg/ml</a:t>
            </a:r>
            <a:endParaRPr lang="en-US" sz="1300" dirty="0"/>
          </a:p>
        </p:txBody>
      </p:sp>
      <p:sp>
        <p:nvSpPr>
          <p:cNvPr id="26" name="TextBox 25"/>
          <p:cNvSpPr txBox="1"/>
          <p:nvPr/>
        </p:nvSpPr>
        <p:spPr>
          <a:xfrm rot="18724095">
            <a:off x="2109329" y="1099691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75 µg/ml</a:t>
            </a:r>
            <a:endParaRPr lang="en-US" sz="1300" dirty="0"/>
          </a:p>
        </p:txBody>
      </p:sp>
      <p:sp>
        <p:nvSpPr>
          <p:cNvPr id="27" name="TextBox 26"/>
          <p:cNvSpPr txBox="1"/>
          <p:nvPr/>
        </p:nvSpPr>
        <p:spPr>
          <a:xfrm rot="18724095">
            <a:off x="3266718" y="1202369"/>
            <a:ext cx="7424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/>
              <a:t>Control</a:t>
            </a:r>
          </a:p>
        </p:txBody>
      </p:sp>
      <p:sp>
        <p:nvSpPr>
          <p:cNvPr id="28" name="TextBox 27"/>
          <p:cNvSpPr txBox="1"/>
          <p:nvPr/>
        </p:nvSpPr>
        <p:spPr>
          <a:xfrm rot="18724095">
            <a:off x="2966191" y="1084292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25 µg/ml</a:t>
            </a:r>
            <a:endParaRPr lang="en-US" sz="1300" dirty="0"/>
          </a:p>
        </p:txBody>
      </p:sp>
      <p:sp>
        <p:nvSpPr>
          <p:cNvPr id="37" name="TextBox 36"/>
          <p:cNvSpPr txBox="1"/>
          <p:nvPr/>
        </p:nvSpPr>
        <p:spPr>
          <a:xfrm rot="18724095">
            <a:off x="3249065" y="1089474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50 µg/ml</a:t>
            </a:r>
            <a:endParaRPr lang="en-US" sz="1300" dirty="0"/>
          </a:p>
        </p:txBody>
      </p:sp>
      <p:sp>
        <p:nvSpPr>
          <p:cNvPr id="42" name="TextBox 41"/>
          <p:cNvSpPr txBox="1"/>
          <p:nvPr/>
        </p:nvSpPr>
        <p:spPr>
          <a:xfrm rot="18724095">
            <a:off x="3557129" y="1084624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75 µg/ml</a:t>
            </a:r>
            <a:endParaRPr lang="en-US" sz="1300" dirty="0"/>
          </a:p>
        </p:txBody>
      </p:sp>
      <p:sp>
        <p:nvSpPr>
          <p:cNvPr id="43" name="TextBox 42"/>
          <p:cNvSpPr txBox="1"/>
          <p:nvPr/>
        </p:nvSpPr>
        <p:spPr>
          <a:xfrm rot="18724095">
            <a:off x="1144143" y="1096581"/>
            <a:ext cx="11165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 smtClean="0"/>
              <a:t>10 µg/ml</a:t>
            </a:r>
            <a:endParaRPr lang="en-US" sz="1300" dirty="0"/>
          </a:p>
        </p:txBody>
      </p:sp>
      <p:sp>
        <p:nvSpPr>
          <p:cNvPr id="44" name="TextBox 43"/>
          <p:cNvSpPr txBox="1"/>
          <p:nvPr/>
        </p:nvSpPr>
        <p:spPr>
          <a:xfrm>
            <a:off x="1695741" y="3623247"/>
            <a:ext cx="2968278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xp.1                             Exp.2</a:t>
            </a:r>
            <a:endParaRPr lang="en-US" dirty="0"/>
          </a:p>
        </p:txBody>
      </p:sp>
      <p:sp>
        <p:nvSpPr>
          <p:cNvPr id="119" name="TextBox 118"/>
          <p:cNvSpPr txBox="1"/>
          <p:nvPr/>
        </p:nvSpPr>
        <p:spPr>
          <a:xfrm>
            <a:off x="8001000" y="1348563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Lowest exposure</a:t>
            </a:r>
            <a:endParaRPr lang="en-US" sz="1400" dirty="0"/>
          </a:p>
        </p:txBody>
      </p:sp>
      <p:sp>
        <p:nvSpPr>
          <p:cNvPr id="120" name="TextBox 119"/>
          <p:cNvSpPr txBox="1"/>
          <p:nvPr/>
        </p:nvSpPr>
        <p:spPr>
          <a:xfrm>
            <a:off x="8001000" y="5344180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Highest exposur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233299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34356" y="4885356"/>
            <a:ext cx="492923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2A.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 of Spike expression at protein level in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use lung tissue treated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.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done using Western blot method with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anti-Spike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noclonal antibody at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:500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lution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µg/well of protein was separated on 8-16% gradient SDS-PAGE gels. Original WB images were acquired using the Azure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Series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gital system and auto-exposure settings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52400" y="181890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prstClr val="black"/>
                </a:solidFill>
              </a:rPr>
              <a:t>Supplementary Figure </a:t>
            </a:r>
            <a:r>
              <a:rPr lang="en-US" dirty="0" smtClean="0">
                <a:solidFill>
                  <a:prstClr val="black"/>
                </a:solidFill>
              </a:rPr>
              <a:t>S2</a:t>
            </a:r>
            <a:endParaRPr lang="en-US" dirty="0">
              <a:solidFill>
                <a:prstClr val="black"/>
              </a:solidFill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941836" y="595758"/>
            <a:ext cx="1826772" cy="228044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968382" y="2428060"/>
            <a:ext cx="1773677" cy="2280440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5985143" y="4237853"/>
            <a:ext cx="1740157" cy="228044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1413706"/>
            <a:ext cx="4448094" cy="3320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Box 41"/>
          <p:cNvSpPr txBox="1"/>
          <p:nvPr/>
        </p:nvSpPr>
        <p:spPr>
          <a:xfrm rot="18724095">
            <a:off x="1366545" y="1192682"/>
            <a:ext cx="16597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post-treatm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8724095">
            <a:off x="2139103" y="1148655"/>
            <a:ext cx="15197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-concurr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8724095">
            <a:off x="3646100" y="1317511"/>
            <a:ext cx="14600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– DMSO only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919208" y="2189326"/>
            <a:ext cx="5750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solidFill>
                  <a:prstClr val="black"/>
                </a:solidFill>
              </a:rPr>
              <a:t>Spike</a:t>
            </a:r>
            <a:endParaRPr lang="en-US" sz="1400" dirty="0">
              <a:solidFill>
                <a:prstClr val="black"/>
              </a:solidFill>
            </a:endParaRPr>
          </a:p>
        </p:txBody>
      </p:sp>
      <p:sp>
        <p:nvSpPr>
          <p:cNvPr id="46" name="TextBox 45"/>
          <p:cNvSpPr txBox="1"/>
          <p:nvPr/>
        </p:nvSpPr>
        <p:spPr>
          <a:xfrm rot="18724095">
            <a:off x="2099544" y="1453825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8724095">
            <a:off x="2670322" y="1511244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urr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 rot="18724095">
            <a:off x="2941297" y="1344572"/>
            <a:ext cx="1447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pre-treatm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8724095">
            <a:off x="3346682" y="1429617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-treatment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8724095">
            <a:off x="4080399" y="1378332"/>
            <a:ext cx="13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trol –LA only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8579230">
            <a:off x="1545801" y="1421922"/>
            <a:ext cx="875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prstClr val="black"/>
                </a:solidFill>
              </a:rPr>
              <a:t>Ladder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55305" y="1044373"/>
            <a:ext cx="497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prstClr val="black"/>
                </a:solidFill>
              </a:rPr>
              <a:t>A                                                                                   </a:t>
            </a:r>
            <a:endParaRPr lang="en-US" dirty="0">
              <a:solidFill>
                <a:prstClr val="black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001000" y="1348563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Lowest exposure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8001000" y="5344180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Highest exposur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124413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63985" y="5036403"/>
            <a:ext cx="456521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B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Spike expression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protein leve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use lung tissue treated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eriment was don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Western blot metho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β-actin antibody 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:250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lution as a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loading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0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g/well of protein was separated on 8-16% gradient SDS-PAGE gels. Original WB images were acquired using the Azur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erie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gital system and auto-exposure settings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52400" y="181890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S2</a:t>
            </a:r>
            <a:endParaRPr lang="en-US" dirty="0"/>
          </a:p>
        </p:txBody>
      </p:sp>
      <p:sp>
        <p:nvSpPr>
          <p:cNvPr id="68" name="TextBox 67"/>
          <p:cNvSpPr txBox="1"/>
          <p:nvPr/>
        </p:nvSpPr>
        <p:spPr>
          <a:xfrm>
            <a:off x="3583159" y="2743200"/>
            <a:ext cx="766399" cy="3166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21897" y="897658"/>
            <a:ext cx="4971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                                                                                   </a:t>
            </a:r>
            <a:endParaRPr lang="en-US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5921272" y="417687"/>
            <a:ext cx="1758374" cy="227667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5851360" y="2305149"/>
            <a:ext cx="1898198" cy="2276672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 flipH="1">
            <a:off x="5886760" y="4227159"/>
            <a:ext cx="1825843" cy="2278228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897" y="1196660"/>
            <a:ext cx="3987819" cy="33052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TextBox 32"/>
          <p:cNvSpPr txBox="1"/>
          <p:nvPr/>
        </p:nvSpPr>
        <p:spPr>
          <a:xfrm rot="18724095">
            <a:off x="882884" y="1178723"/>
            <a:ext cx="16597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post-treatm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8724095">
            <a:off x="1382475" y="1293151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8724095">
            <a:off x="1655442" y="1134696"/>
            <a:ext cx="15197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-concurr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rot="18724095">
            <a:off x="1953253" y="1350570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urr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8724095">
            <a:off x="2224228" y="1183898"/>
            <a:ext cx="14472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pre-treatm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8724095">
            <a:off x="2629613" y="1268943"/>
            <a:ext cx="111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-treatme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8724095">
            <a:off x="2929031" y="1156837"/>
            <a:ext cx="14600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– DMSO only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8724095">
            <a:off x="3363330" y="1217658"/>
            <a:ext cx="13459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 –LA only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8579230">
            <a:off x="828732" y="1261248"/>
            <a:ext cx="875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001000" y="1348563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Lowest exposure</a:t>
            </a:r>
            <a:endParaRPr lang="en-US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8001000" y="5344180"/>
            <a:ext cx="1143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 smtClean="0"/>
              <a:t>Highest exposure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248453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</TotalTime>
  <Words>311</Words>
  <Application>Microsoft Office PowerPoint</Application>
  <PresentationFormat>On-screen Show (4:3)</PresentationFormat>
  <Paragraphs>48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Linoleic acid binds to SARS-CoV-2 RdRp and represses replication of seasonal human coronavirus OC43   Anna Goc1*, Waldemar Sumera1, Matthias Rath1, Aleksandra Niedzwiecki1* 1Dr. Rath Research Institute, 5941 Optical Ct., San Jose, CA 95138, USA 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Goc</dc:creator>
  <cp:lastModifiedBy>Anna Goc</cp:lastModifiedBy>
  <cp:revision>42</cp:revision>
  <dcterms:created xsi:type="dcterms:W3CDTF">2020-10-28T20:48:59Z</dcterms:created>
  <dcterms:modified xsi:type="dcterms:W3CDTF">2022-11-03T17:05:13Z</dcterms:modified>
</cp:coreProperties>
</file>